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66" r:id="rId3"/>
    <p:sldId id="267" r:id="rId4"/>
    <p:sldId id="268" r:id="rId5"/>
    <p:sldId id="269" r:id="rId6"/>
    <p:sldId id="270" r:id="rId7"/>
    <p:sldId id="271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89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24" y="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4413DF-CB0A-FA43-9698-A04B8531C5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7409CE9-0CAA-554D-83EE-0AF5DFD112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53B7B5-6284-B84F-872E-FC5C23DCD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8C995F-ABB6-EE40-B179-BD2FB1CFC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08B6FA-7E13-3C4F-8434-081DAB36D2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59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C2BF64-F923-944C-97BA-D9D71882D6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FBDC1C-EC59-9F4C-9310-241D590182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70AC9B-03ED-7E4C-A7D5-50264FD217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BA9E74-BF20-9542-BA29-83CB188AF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2443F9-0448-C94D-B2AF-9DA5731D9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289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481751D-330A-A648-95E6-62C7066AB2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86DC58-30BD-C04E-BFEA-9AC8F8FCA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D4357F-8BE0-BE42-99F0-033D54E466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E1E0EA-44C1-1043-89FB-D977922AC5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E30E46-6DD6-D04B-B0AE-D6A667B8D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966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64EE06-79AD-F745-B19A-9C9F2FD62F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D69614-C2F0-AE4A-B4B9-3F1A8DB651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DBA511-D97E-9849-8BA2-CB80BAD4B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D289C1-97AA-CE41-B26E-85E21E01B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F970C2-BA61-BB43-8F77-7C1E57A04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654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801432-2E3C-D64E-AB88-2C28D654ED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C4D766-8647-0240-AAE1-98DFB2699D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F35D00-736F-7B43-8300-6769CFCFF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C44BB4-938F-DE4B-97BB-DC29001E89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C050C8-42E8-864B-896E-C43ECBB7D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076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04EA6D-5453-9E47-93D1-6F00B16A59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FE3DEF-1F48-274F-BFF4-2C356B57AB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9A0DF3-75A2-774C-BCA1-9AF0AE1248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D1C84C-1DCC-5146-B71D-FEBC5F8AC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86E875-719A-8845-B695-5D8E9700E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CF98FD-8E47-8149-BC35-5B8A84B26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497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ECE94C-52E5-D448-9992-456D017232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7F27E6-138A-0F4A-9281-18CD9FCE2B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8D995A-AEC4-2043-8864-7B68D17982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BF92CED-9105-5149-94C6-74DB618C7A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EA9B8BF-5824-0342-BD89-E17F0D7BD5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61A3D04-6AE9-4B4D-B127-6EC9EB9ADC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7EA1CD0-2C81-D148-A90B-11352EA46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3A4AAC-C779-3341-83AD-EE1D0CEEE2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870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FBE30E-52D2-F14B-A359-50083CCEE2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458C05-2CB2-F74F-B932-20FED6663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D77DF90-6081-E64D-8C65-5E116F0EB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FB5C31D-FAA6-1A48-B10A-E6B496927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238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0CCF272-C401-4E44-8FE5-3E92DBBE3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D17461C-D62D-F24D-8418-3224DB2537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BC0683A-40D2-574B-91D5-925B557C2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169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1CD60-48B0-D94F-A1B7-473D2EB9EA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D8BFF9-94FB-8C48-96F0-DF1D1F62EA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3F3D75-8476-254A-8943-E6B4ECB4FC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431D5F-1089-2541-BD65-2D0A701993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CE5872-5B3B-E54F-AFE7-1B2D3839D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0E6857-805D-A742-B110-B399F77B8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520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21AB8D-E605-F648-8021-306BCA72C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E1EC4D-09C7-6644-BB38-C23B92A725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B0AE97-C54A-F84C-9E1B-F1CD48A50B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7D0B9D-AC0A-6D44-B890-6B75DEE59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0D6DB9-AD71-7141-AEA8-6BCB0E318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2B5365-244F-E548-87AD-59F214B89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34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4CFA2C1-55E3-B442-A3CD-AD26DF2471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D948FF-8404-0F4D-9C91-B3DB689BEC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45F492-5B33-0D45-A660-C4AA596170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AC6B80-51AA-3843-B5E2-72DA6CAD35E4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B760FF-C70B-AB48-8BFF-D2F3166EA0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113F17-4EDA-DA48-B9E5-9F25CB9E51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496484-5E8D-E048-9D08-987678F367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498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849AA1-C0B3-A74B-B105-13A268F2C5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66931" y="1340629"/>
            <a:ext cx="10458138" cy="2387600"/>
          </a:xfrm>
        </p:spPr>
        <p:txBody>
          <a:bodyPr>
            <a:normAutofit fontScale="90000"/>
          </a:bodyPr>
          <a:lstStyle/>
          <a:p>
            <a:r>
              <a:rPr lang="en-US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Mixed-effects logistic regression model outputs with specialist and general science journals separated</a:t>
            </a:r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3966BC1-7B45-774A-BF00-1BB3BBFF16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4001511"/>
            <a:ext cx="9144000" cy="1655762"/>
          </a:xfrm>
        </p:spPr>
        <p:txBody>
          <a:bodyPr/>
          <a:lstStyle/>
          <a:p>
            <a:r>
              <a:rPr lang="en-US" dirty="0"/>
              <a:t>Supplementary STATA outputs</a:t>
            </a:r>
          </a:p>
        </p:txBody>
      </p:sp>
    </p:spTree>
    <p:extLst>
      <p:ext uri="{BB962C8B-B14F-4D97-AF65-F5344CB8AC3E}">
        <p14:creationId xmlns:p14="http://schemas.microsoft.com/office/powerpoint/2010/main" val="37541803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screenshot of a computer&#10;&#10;Description automatically generated">
            <a:extLst>
              <a:ext uri="{FF2B5EF4-FFF2-40B4-BE49-F238E27FC236}">
                <a16:creationId xmlns:a16="http://schemas.microsoft.com/office/drawing/2014/main" id="{38599B86-08A3-3849-836C-927BDABAA4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9966" y="0"/>
            <a:ext cx="9452067" cy="685800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6FC2BAEF-7FBD-7044-B37A-0F1DE1901F07}"/>
              </a:ext>
            </a:extLst>
          </p:cNvPr>
          <p:cNvSpPr/>
          <p:nvPr/>
        </p:nvSpPr>
        <p:spPr>
          <a:xfrm>
            <a:off x="5846150" y="2521342"/>
            <a:ext cx="648918" cy="15587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D7BFC85C-9B7D-4341-A50E-A9F3DC253809}"/>
              </a:ext>
            </a:extLst>
          </p:cNvPr>
          <p:cNvSpPr/>
          <p:nvPr/>
        </p:nvSpPr>
        <p:spPr>
          <a:xfrm>
            <a:off x="1369966" y="3002419"/>
            <a:ext cx="5125101" cy="29162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91FADD5-4D62-BC47-A4DD-287DF672E3A9}"/>
              </a:ext>
            </a:extLst>
          </p:cNvPr>
          <p:cNvSpPr/>
          <p:nvPr/>
        </p:nvSpPr>
        <p:spPr>
          <a:xfrm>
            <a:off x="5210978" y="3429000"/>
            <a:ext cx="1284088" cy="29162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2CD0CD3-B5D9-C045-B489-AB24131DC290}"/>
              </a:ext>
            </a:extLst>
          </p:cNvPr>
          <p:cNvSpPr txBox="1"/>
          <p:nvPr/>
        </p:nvSpPr>
        <p:spPr>
          <a:xfrm>
            <a:off x="4461832" y="2786975"/>
            <a:ext cx="1143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With respect to </a:t>
            </a:r>
            <a:r>
              <a:rPr lang="en-US" sz="800" i="1" dirty="0"/>
              <a:t>Nature</a:t>
            </a:r>
            <a:endParaRPr lang="en-US" sz="800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B743AEF-7002-4545-AFAA-DD491BA53B7A}"/>
              </a:ext>
            </a:extLst>
          </p:cNvPr>
          <p:cNvSpPr/>
          <p:nvPr/>
        </p:nvSpPr>
        <p:spPr>
          <a:xfrm>
            <a:off x="5960124" y="5754205"/>
            <a:ext cx="525087" cy="172870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7804E7C-7BB8-6D43-978E-15FE7144E849}"/>
              </a:ext>
            </a:extLst>
          </p:cNvPr>
          <p:cNvSpPr/>
          <p:nvPr/>
        </p:nvSpPr>
        <p:spPr>
          <a:xfrm>
            <a:off x="5831407" y="6218526"/>
            <a:ext cx="648918" cy="15587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6B4EF8D-44D8-3E44-9606-C1616D9CDE5B}"/>
              </a:ext>
            </a:extLst>
          </p:cNvPr>
          <p:cNvSpPr txBox="1"/>
          <p:nvPr/>
        </p:nvSpPr>
        <p:spPr>
          <a:xfrm>
            <a:off x="9568292" y="0"/>
            <a:ext cx="25074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neral Science Journals</a:t>
            </a:r>
          </a:p>
          <a:p>
            <a:r>
              <a:rPr lang="en-US" dirty="0"/>
              <a:t>Continent</a:t>
            </a:r>
          </a:p>
        </p:txBody>
      </p:sp>
    </p:spTree>
    <p:extLst>
      <p:ext uri="{BB962C8B-B14F-4D97-AF65-F5344CB8AC3E}">
        <p14:creationId xmlns:p14="http://schemas.microsoft.com/office/powerpoint/2010/main" val="25512666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document&#10;&#10;Description automatically generated">
            <a:extLst>
              <a:ext uri="{FF2B5EF4-FFF2-40B4-BE49-F238E27FC236}">
                <a16:creationId xmlns:a16="http://schemas.microsoft.com/office/drawing/2014/main" id="{F681BEA8-1AEA-E94D-9AE3-277856736B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3880" y="0"/>
            <a:ext cx="8544239" cy="68580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1549E87A-FEF4-6C4A-9806-7B9EAE31E793}"/>
              </a:ext>
            </a:extLst>
          </p:cNvPr>
          <p:cNvSpPr/>
          <p:nvPr/>
        </p:nvSpPr>
        <p:spPr>
          <a:xfrm>
            <a:off x="5771540" y="2278971"/>
            <a:ext cx="648918" cy="15587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91D9869-9D95-B847-A916-6C78512DECCC}"/>
              </a:ext>
            </a:extLst>
          </p:cNvPr>
          <p:cNvSpPr/>
          <p:nvPr/>
        </p:nvSpPr>
        <p:spPr>
          <a:xfrm>
            <a:off x="5771540" y="6243207"/>
            <a:ext cx="648918" cy="15587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E417415-44C3-254D-B744-7DB2AFC2CD6A}"/>
              </a:ext>
            </a:extLst>
          </p:cNvPr>
          <p:cNvSpPr/>
          <p:nvPr/>
        </p:nvSpPr>
        <p:spPr>
          <a:xfrm>
            <a:off x="1740665" y="2671913"/>
            <a:ext cx="4679793" cy="29162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74CFCA0-E2DD-C74A-88EF-E3362406871C}"/>
              </a:ext>
            </a:extLst>
          </p:cNvPr>
          <p:cNvSpPr/>
          <p:nvPr/>
        </p:nvSpPr>
        <p:spPr>
          <a:xfrm>
            <a:off x="5188945" y="3065813"/>
            <a:ext cx="1217361" cy="29162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3FAB767-2FD1-2C4C-B1C5-1A287D6C0B06}"/>
              </a:ext>
            </a:extLst>
          </p:cNvPr>
          <p:cNvSpPr/>
          <p:nvPr/>
        </p:nvSpPr>
        <p:spPr>
          <a:xfrm>
            <a:off x="5409282" y="4644451"/>
            <a:ext cx="997024" cy="15587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DBF9551-8EB8-2C46-B129-0CD6137942F9}"/>
              </a:ext>
            </a:extLst>
          </p:cNvPr>
          <p:cNvSpPr/>
          <p:nvPr/>
        </p:nvSpPr>
        <p:spPr>
          <a:xfrm>
            <a:off x="5925671" y="5320613"/>
            <a:ext cx="480635" cy="155870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74BC531-3B93-274C-925E-ABF22F42E1EA}"/>
              </a:ext>
            </a:extLst>
          </p:cNvPr>
          <p:cNvSpPr txBox="1"/>
          <p:nvPr/>
        </p:nvSpPr>
        <p:spPr>
          <a:xfrm>
            <a:off x="9684519" y="0"/>
            <a:ext cx="25074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neral Science Journals</a:t>
            </a:r>
          </a:p>
          <a:p>
            <a:r>
              <a:rPr lang="en-US" dirty="0"/>
              <a:t>Subcontinen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85D8DF9-5DF5-0447-8B47-E0C7EB816010}"/>
              </a:ext>
            </a:extLst>
          </p:cNvPr>
          <p:cNvSpPr txBox="1"/>
          <p:nvPr/>
        </p:nvSpPr>
        <p:spPr>
          <a:xfrm>
            <a:off x="4538032" y="2479050"/>
            <a:ext cx="1143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With respect to </a:t>
            </a:r>
            <a:r>
              <a:rPr lang="en-US" sz="800" i="1" dirty="0"/>
              <a:t>Nature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37190389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E96D8CA2-5146-ED40-BC4C-895EDA63ED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3556" y="0"/>
            <a:ext cx="7904887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1D822E1-9C93-F64A-BD79-D09B4F91E653}"/>
              </a:ext>
            </a:extLst>
          </p:cNvPr>
          <p:cNvSpPr/>
          <p:nvPr/>
        </p:nvSpPr>
        <p:spPr>
          <a:xfrm>
            <a:off x="2143557" y="2514659"/>
            <a:ext cx="4307574" cy="246469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A3993606-2783-E64D-98A0-1203758A3F35}"/>
              </a:ext>
            </a:extLst>
          </p:cNvPr>
          <p:cNvSpPr/>
          <p:nvPr/>
        </p:nvSpPr>
        <p:spPr>
          <a:xfrm>
            <a:off x="2143555" y="2882212"/>
            <a:ext cx="4307574" cy="246469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F44F2C8-DE0E-1F4F-A879-E457B7792E8B}"/>
              </a:ext>
            </a:extLst>
          </p:cNvPr>
          <p:cNvSpPr/>
          <p:nvPr/>
        </p:nvSpPr>
        <p:spPr>
          <a:xfrm>
            <a:off x="5802211" y="2126571"/>
            <a:ext cx="648918" cy="15587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2738F49-FCA5-EC46-AEE7-188C99734DE4}"/>
              </a:ext>
            </a:extLst>
          </p:cNvPr>
          <p:cNvSpPr/>
          <p:nvPr/>
        </p:nvSpPr>
        <p:spPr>
          <a:xfrm>
            <a:off x="5802211" y="6456524"/>
            <a:ext cx="648918" cy="15587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9CABA8D-8D00-AB47-844C-6214EDE861BB}"/>
              </a:ext>
            </a:extLst>
          </p:cNvPr>
          <p:cNvSpPr txBox="1"/>
          <p:nvPr/>
        </p:nvSpPr>
        <p:spPr>
          <a:xfrm>
            <a:off x="9684519" y="0"/>
            <a:ext cx="25074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neral Science Journals</a:t>
            </a:r>
          </a:p>
          <a:p>
            <a:r>
              <a:rPr lang="en-US" dirty="0"/>
              <a:t>Country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19E89EF-08ED-E24A-B771-DE29C02B146F}"/>
              </a:ext>
            </a:extLst>
          </p:cNvPr>
          <p:cNvSpPr txBox="1"/>
          <p:nvPr/>
        </p:nvSpPr>
        <p:spPr>
          <a:xfrm>
            <a:off x="4658949" y="2299215"/>
            <a:ext cx="1143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With respect to </a:t>
            </a:r>
            <a:r>
              <a:rPr lang="en-US" sz="800" i="1" dirty="0"/>
              <a:t>Nature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30304610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omputer&#10;&#10;Description automatically generated">
            <a:extLst>
              <a:ext uri="{FF2B5EF4-FFF2-40B4-BE49-F238E27FC236}">
                <a16:creationId xmlns:a16="http://schemas.microsoft.com/office/drawing/2014/main" id="{AB4F2E88-887B-FD42-BD54-08FF6E7E3C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9191" y="0"/>
            <a:ext cx="7653618" cy="68580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D85A7710-AE34-DA4B-8387-3DF0118CB3D7}"/>
              </a:ext>
            </a:extLst>
          </p:cNvPr>
          <p:cNvSpPr/>
          <p:nvPr/>
        </p:nvSpPr>
        <p:spPr>
          <a:xfrm>
            <a:off x="2743200" y="6104805"/>
            <a:ext cx="774724" cy="177242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D6EC12A-E99B-564E-BE05-54D4FC38A977}"/>
              </a:ext>
            </a:extLst>
          </p:cNvPr>
          <p:cNvSpPr txBox="1"/>
          <p:nvPr/>
        </p:nvSpPr>
        <p:spPr>
          <a:xfrm>
            <a:off x="9636492" y="0"/>
            <a:ext cx="25555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ecialist (only </a:t>
            </a:r>
            <a:r>
              <a:rPr lang="en-US" i="1" dirty="0"/>
              <a:t>Antiquity</a:t>
            </a:r>
            <a:r>
              <a:rPr lang="en-US" dirty="0"/>
              <a:t>)</a:t>
            </a:r>
          </a:p>
          <a:p>
            <a:r>
              <a:rPr lang="en-US" dirty="0"/>
              <a:t>Continent</a:t>
            </a:r>
          </a:p>
        </p:txBody>
      </p:sp>
    </p:spTree>
    <p:extLst>
      <p:ext uri="{BB962C8B-B14F-4D97-AF65-F5344CB8AC3E}">
        <p14:creationId xmlns:p14="http://schemas.microsoft.com/office/powerpoint/2010/main" val="38287373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7B77DBCE-2902-4B41-A09B-4B79867BC3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2863" y="0"/>
            <a:ext cx="6706274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15480C0-E9A3-C443-A558-B2E7151095CA}"/>
              </a:ext>
            </a:extLst>
          </p:cNvPr>
          <p:cNvSpPr/>
          <p:nvPr/>
        </p:nvSpPr>
        <p:spPr>
          <a:xfrm>
            <a:off x="3284643" y="6247308"/>
            <a:ext cx="648918" cy="15587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A81F5FA-FA7C-E642-A0FD-99DE361BC296}"/>
              </a:ext>
            </a:extLst>
          </p:cNvPr>
          <p:cNvSpPr txBox="1"/>
          <p:nvPr/>
        </p:nvSpPr>
        <p:spPr>
          <a:xfrm>
            <a:off x="9636492" y="0"/>
            <a:ext cx="25555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ecialist (only </a:t>
            </a:r>
            <a:r>
              <a:rPr lang="en-US" i="1" dirty="0"/>
              <a:t>Antiquity</a:t>
            </a:r>
            <a:r>
              <a:rPr lang="en-US" dirty="0"/>
              <a:t>)</a:t>
            </a:r>
          </a:p>
          <a:p>
            <a:r>
              <a:rPr lang="en-US" dirty="0"/>
              <a:t>Subcontinent</a:t>
            </a:r>
          </a:p>
        </p:txBody>
      </p:sp>
    </p:spTree>
    <p:extLst>
      <p:ext uri="{BB962C8B-B14F-4D97-AF65-F5344CB8AC3E}">
        <p14:creationId xmlns:p14="http://schemas.microsoft.com/office/powerpoint/2010/main" val="1601937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document&#10;&#10;Description automatically generated">
            <a:extLst>
              <a:ext uri="{FF2B5EF4-FFF2-40B4-BE49-F238E27FC236}">
                <a16:creationId xmlns:a16="http://schemas.microsoft.com/office/drawing/2014/main" id="{43FE204C-54A6-BF4F-82C6-CD9718B2DC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6562" y="0"/>
            <a:ext cx="5678875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58C0BD9-B77A-344A-A6F8-F20128AD7669}"/>
              </a:ext>
            </a:extLst>
          </p:cNvPr>
          <p:cNvSpPr/>
          <p:nvPr/>
        </p:nvSpPr>
        <p:spPr>
          <a:xfrm>
            <a:off x="3548539" y="6292171"/>
            <a:ext cx="648918" cy="15587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4DCD688-4EC7-2C46-8CB4-A17877FA4F5B}"/>
              </a:ext>
            </a:extLst>
          </p:cNvPr>
          <p:cNvSpPr/>
          <p:nvPr/>
        </p:nvSpPr>
        <p:spPr>
          <a:xfrm>
            <a:off x="3548539" y="5957454"/>
            <a:ext cx="648918" cy="8865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CDA1827-F6E6-114D-AE9C-94ED582E98AD}"/>
              </a:ext>
            </a:extLst>
          </p:cNvPr>
          <p:cNvSpPr/>
          <p:nvPr/>
        </p:nvSpPr>
        <p:spPr>
          <a:xfrm>
            <a:off x="3479266" y="5361708"/>
            <a:ext cx="648918" cy="8865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6923E51-3BA2-E247-A3CE-DD1A9556A327}"/>
              </a:ext>
            </a:extLst>
          </p:cNvPr>
          <p:cNvSpPr/>
          <p:nvPr/>
        </p:nvSpPr>
        <p:spPr>
          <a:xfrm>
            <a:off x="3548068" y="4276435"/>
            <a:ext cx="648918" cy="8865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4F38E7-50DC-BF45-9FF5-B8C6FC2D1656}"/>
              </a:ext>
            </a:extLst>
          </p:cNvPr>
          <p:cNvSpPr txBox="1"/>
          <p:nvPr/>
        </p:nvSpPr>
        <p:spPr>
          <a:xfrm>
            <a:off x="9583594" y="29817"/>
            <a:ext cx="260840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ecialist (only </a:t>
            </a:r>
            <a:r>
              <a:rPr lang="en-US" i="1" dirty="0"/>
              <a:t>Antiquity</a:t>
            </a:r>
            <a:r>
              <a:rPr lang="en-US" dirty="0"/>
              <a:t>) </a:t>
            </a:r>
          </a:p>
          <a:p>
            <a:r>
              <a:rPr lang="en-US" dirty="0"/>
              <a:t>Country</a:t>
            </a:r>
          </a:p>
        </p:txBody>
      </p:sp>
    </p:spTree>
    <p:extLst>
      <p:ext uri="{BB962C8B-B14F-4D97-AF65-F5344CB8AC3E}">
        <p14:creationId xmlns:p14="http://schemas.microsoft.com/office/powerpoint/2010/main" val="3100286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57</Words>
  <Application>Microsoft Macintosh PowerPoint</Application>
  <PresentationFormat>Widescreen</PresentationFormat>
  <Paragraphs>1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Mixed-effects logistic regression model outputs with specialist and general science journals separated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xed-effects logistic regression model outputs for individual news outlets and EurekAlert!</dc:title>
  <dc:creator>Jenny Ji</dc:creator>
  <cp:lastModifiedBy>Alex, Bridget A.</cp:lastModifiedBy>
  <cp:revision>10</cp:revision>
  <dcterms:created xsi:type="dcterms:W3CDTF">2025-03-09T18:50:35Z</dcterms:created>
  <dcterms:modified xsi:type="dcterms:W3CDTF">2025-03-10T14:55:45Z</dcterms:modified>
</cp:coreProperties>
</file>